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2" r:id="rId2"/>
    <p:sldId id="273" r:id="rId3"/>
    <p:sldId id="274" r:id="rId4"/>
    <p:sldId id="263" r:id="rId5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sabel Henriques" initials="IH" lastIdx="6" clrIdx="0">
    <p:extLst>
      <p:ext uri="{19B8F6BF-5375-455C-9EA6-DF929625EA0E}">
        <p15:presenceInfo xmlns:p15="http://schemas.microsoft.com/office/powerpoint/2012/main" userId="S::ihenriques@ua.pt::855e89a6-c13d-4ee2-808e-9a543bf9d922" providerId="AD"/>
      </p:ext>
    </p:extLst>
  </p:cmAuthor>
  <p:cmAuthor id="2" name="Margarita Gomila Ribas" initials="MGR" lastIdx="1" clrIdx="1">
    <p:extLst>
      <p:ext uri="{19B8F6BF-5375-455C-9EA6-DF929625EA0E}">
        <p15:presenceInfo xmlns:p15="http://schemas.microsoft.com/office/powerpoint/2012/main" userId="Margarita Gomila Ribas" providerId="None"/>
      </p:ext>
    </p:extLst>
  </p:cmAuthor>
  <p:cmAuthor id="3" name="Jaqueline Rocha" initials="JR" lastIdx="3" clrIdx="2">
    <p:extLst>
      <p:ext uri="{19B8F6BF-5375-455C-9EA6-DF929625EA0E}">
        <p15:presenceInfo xmlns:p15="http://schemas.microsoft.com/office/powerpoint/2012/main" userId="Jaqueline Roch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4" autoAdjust="0"/>
    <p:restoredTop sz="93629" autoAdjust="0"/>
  </p:normalViewPr>
  <p:slideViewPr>
    <p:cSldViewPr snapToGrid="0">
      <p:cViewPr varScale="1">
        <p:scale>
          <a:sx n="62" d="100"/>
          <a:sy n="62" d="100"/>
        </p:scale>
        <p:origin x="118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A15250B-2140-4394-BD92-3DA8050562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20EC4110-E2FD-4E9A-BBA3-FCF7070A37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25AF85A2-BD2A-45C9-9BE3-A2BE21B01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C6EF369D-0CB7-4773-891D-1CF042AE41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D83452EB-51DE-4C7D-A37E-7D6D86BE0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04656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FA4F50-31CC-4791-B131-15EA1F5A0F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E5630CAB-AE47-474B-8C5A-6DD5AA3855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22ED2272-52E3-47D8-B2C7-AC345DC085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D8B9CDB3-A483-4A31-8D3B-8927E8C00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A6882ED-CD2C-4B7A-B8E4-6E09B44FCE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38880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418E130-051F-4516-8F95-FBE8FEF794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1EA1C7B6-B3C8-46FA-A0B4-DA2FB60D55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F4BFDE3-B0D8-4C27-9ACA-C8A8EAB0F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4B2970AF-75F9-45B1-AB64-CD629CA29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F7AD6E2B-C226-48E5-92DB-C08FD534E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683233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4C81BC5-D98D-4144-8122-BCD063914A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CE2665A9-3EED-4EBC-886A-6E5A093E93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86308302-1594-4BF1-A68F-89D6AB223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AAD32DFA-A2EF-4390-951F-BA1CEAE2B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475791D1-04BE-4B6E-84F3-D8B4BF164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283679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88DC9C4-07E1-4AD6-A339-7E406D1E2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7A422173-D4EE-4E32-8A35-0FAAE81250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35A77013-ED70-4C3F-BE6F-3B7EF5EF0B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DBE0E011-B979-4445-8C55-4FA47CCA2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A606C212-DAAA-459D-A026-8573EF623E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72770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234D028-1C1E-462D-96E4-4312BA220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53076F48-3897-4CF8-955C-13499B402C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EFFF4A4E-4326-4ABD-ABE1-6EF4AC8BCD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A03FCE9B-ED10-4CC5-84A8-D3D5E8B405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0F8B97E5-974A-42A9-B321-5BE250FC4F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331039AA-694D-486D-B581-B7D84737C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739858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7BE6C07-4B1D-4E50-BB25-ED4A42504A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1F6D0FEE-879C-4025-B225-4015CDB388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57F8959E-7425-40E4-A686-C09CD0763A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CDDB21DE-AC04-48D9-9DC7-58CDB4C90F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42FC1EAD-8D48-4F96-A62B-BC732EDDEB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47DB768F-6F27-44E6-A6D1-514EDCE7D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CDF3BC6F-0169-4DE8-8482-554EA9041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C834571C-4B23-41C3-A945-39AD60EF8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27700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373DA9-8383-4308-B455-9BF985A3F0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01131C14-875F-4CCA-A272-63C464014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A387706B-1EA7-4F76-97BD-577581098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92361CB6-41A5-46B0-AA86-A60D421B8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090929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11BCB047-FC79-4FE4-9E6D-7B8335147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2FD3667F-7316-4D33-84E8-021647CCD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D297225D-4106-4A0E-981E-CFB62005AE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602096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81DDECF-B893-444E-B81C-3A9514517B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45CFA60C-C46D-402E-BFE7-6737F42BE5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9A75CB0A-B17E-4427-8668-72458AE7B8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B8BDE8E6-CAEC-4510-B176-2059FC3DC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19052030-7C5C-48C4-9D0A-C762B6A05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C6423465-BF36-463D-A18B-DF1DCE75F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996285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6C095D9-5EEE-4BA5-A780-ADE4244E22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F0C63728-CFB2-4A6A-BD14-C3B6A6A23F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865B05F1-86A1-4EE9-8C38-9E83C80313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FB6ECCD4-C0F2-49D7-9727-7CA63F0D5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A1FDD697-BCC5-42B1-AEB2-ECAADC3DA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122AA691-D8F9-4A27-AF2C-10A412DD0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17042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6CF1C1A0-70C7-44EC-A958-8A2398A34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B1CCF24D-3201-420C-A059-0F5502FE59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B52BACB8-F41F-43E1-A8FC-4EA898674B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A06C2-A1BD-42EB-A620-07657C8E4988}" type="datetimeFigureOut">
              <a:rPr lang="pt-PT" smtClean="0"/>
              <a:t>08/09/2021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F0B76EAF-D70B-4A0A-A9C8-1ABB1CA4AB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F900AFE2-A7E5-4197-9C97-A4B03B4A97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B143FC-38D3-408D-BFD6-55566E2548CB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40874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>
            <a:extLst>
              <a:ext uri="{FF2B5EF4-FFF2-40B4-BE49-F238E27FC236}">
                <a16:creationId xmlns:a16="http://schemas.microsoft.com/office/drawing/2014/main" id="{70ACC379-6CF4-4D5E-874A-17A8BD3CB7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2775"/>
            <a:ext cx="12192000" cy="4649350"/>
          </a:xfrm>
          <a:prstGeom prst="rect">
            <a:avLst/>
          </a:prstGeom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26EBEEFC-C75A-4106-AF87-89772BA6A6E8}"/>
              </a:ext>
            </a:extLst>
          </p:cNvPr>
          <p:cNvSpPr txBox="1"/>
          <p:nvPr/>
        </p:nvSpPr>
        <p:spPr>
          <a:xfrm>
            <a:off x="0" y="4857473"/>
            <a:ext cx="12031038" cy="7745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 S1-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Genetic environment of tellurium (</a:t>
            </a:r>
            <a:r>
              <a:rPr lang="en-US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er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resistance-related genes. Blue arrows indicate the genes related to tellurium resistance and yellow arrows refer to hypothetical proteins.</a:t>
            </a:r>
            <a:endParaRPr lang="pt-P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61284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E0A3EE74-4882-4761-B09A-DB1DEA8A89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3802" y="0"/>
            <a:ext cx="9031582" cy="5976092"/>
          </a:xfrm>
          <a:prstGeom prst="rect">
            <a:avLst/>
          </a:prstGeom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F18E71A9-4864-484D-84F7-87607BEDD92D}"/>
              </a:ext>
            </a:extLst>
          </p:cNvPr>
          <p:cNvSpPr txBox="1"/>
          <p:nvPr/>
        </p:nvSpPr>
        <p:spPr>
          <a:xfrm>
            <a:off x="213187" y="5916115"/>
            <a:ext cx="11889769" cy="7745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 S2-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Genetic environment of arsenic (</a:t>
            </a:r>
            <a:r>
              <a:rPr lang="en-US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r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, copper (</a:t>
            </a:r>
            <a:r>
              <a:rPr lang="en-US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co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nd silver (</a:t>
            </a:r>
            <a:r>
              <a:rPr lang="en-US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il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resistance-related genes. Blue arrows indicate genes related to resistance to arsenic, copper and arsenic metals, yellow arrows refer to hypothetical proteins.</a:t>
            </a:r>
            <a:endParaRPr lang="pt-P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83956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159CC2F5-2CD4-4019-9113-82A42506372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4018" y="426460"/>
            <a:ext cx="6262157" cy="3867225"/>
          </a:xfrm>
          <a:prstGeom prst="rect">
            <a:avLst/>
          </a:prstGeom>
        </p:spPr>
      </p:pic>
      <p:sp>
        <p:nvSpPr>
          <p:cNvPr id="4" name="CaixaDeTexto 3">
            <a:extLst>
              <a:ext uri="{FF2B5EF4-FFF2-40B4-BE49-F238E27FC236}">
                <a16:creationId xmlns:a16="http://schemas.microsoft.com/office/drawing/2014/main" id="{1D8FBB7C-3047-40BC-983F-0381BC68D582}"/>
              </a:ext>
            </a:extLst>
          </p:cNvPr>
          <p:cNvSpPr txBox="1"/>
          <p:nvPr/>
        </p:nvSpPr>
        <p:spPr>
          <a:xfrm>
            <a:off x="151544" y="4538975"/>
            <a:ext cx="11191126" cy="7745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 S3-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Genetic context of mercury (</a:t>
            </a:r>
            <a:r>
              <a:rPr lang="en-US" sz="12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er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resistance-related genes. Blue arrows indicate the genes related to mercury resistance and yellow arrows refer to hypothetical proteins.</a:t>
            </a:r>
            <a:endParaRPr lang="pt-P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24943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>
            <a:extLst>
              <a:ext uri="{FF2B5EF4-FFF2-40B4-BE49-F238E27FC236}">
                <a16:creationId xmlns:a16="http://schemas.microsoft.com/office/drawing/2014/main" id="{A6FE233D-EDD8-4958-9650-C00BA6F9EF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72406"/>
            <a:ext cx="12192000" cy="4069111"/>
          </a:xfrm>
          <a:prstGeom prst="rect">
            <a:avLst/>
          </a:prstGeom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0EB12316-FB0E-4CF5-8A81-48BF3EDD3DE1}"/>
              </a:ext>
            </a:extLst>
          </p:cNvPr>
          <p:cNvSpPr txBox="1"/>
          <p:nvPr/>
        </p:nvSpPr>
        <p:spPr>
          <a:xfrm>
            <a:off x="79624" y="4338629"/>
            <a:ext cx="11797301" cy="7745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igure S4-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Genetic environment of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yersiniabactin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virulence locus. Blue arrows indicate genes related to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yersiniabactin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virulence and yellow arrows refer to hypothetical proteins.</a:t>
            </a:r>
            <a:endParaRPr lang="pt-PT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500475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619</TotalTime>
  <Words>126</Words>
  <Application>Microsoft Office PowerPoint</Application>
  <PresentationFormat>Ecrã Panorâmico</PresentationFormat>
  <Paragraphs>4</Paragraphs>
  <Slides>4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Jaqueline Rocha</dc:creator>
  <cp:lastModifiedBy>Jaqueline Rocha</cp:lastModifiedBy>
  <cp:revision>156</cp:revision>
  <dcterms:created xsi:type="dcterms:W3CDTF">2020-08-12T11:05:23Z</dcterms:created>
  <dcterms:modified xsi:type="dcterms:W3CDTF">2021-09-08T16:19:30Z</dcterms:modified>
</cp:coreProperties>
</file>